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7" r:id="rId3"/>
    <p:sldId id="258" r:id="rId4"/>
    <p:sldId id="259" r:id="rId5"/>
    <p:sldId id="25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607" autoAdjust="0"/>
    <p:restoredTop sz="94660"/>
  </p:normalViewPr>
  <p:slideViewPr>
    <p:cSldViewPr snapToGrid="0">
      <p:cViewPr varScale="1">
        <p:scale>
          <a:sx n="75" d="100"/>
          <a:sy n="75" d="100"/>
        </p:scale>
        <p:origin x="7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2522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969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7714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7235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8409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83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1638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1040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038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030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031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ADCD1-839D-4B48-A400-52CDA2D8D3B6}" type="datetimeFigureOut">
              <a:rPr lang="ko-KR" altLang="en-US" smtClean="0"/>
              <a:t>2024-06-28(Fri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90CED-E5CA-441B-8B39-FA66A357C0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8912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37784" y="565386"/>
            <a:ext cx="656363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minivi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licons for protein expression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minivi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licons comprise a sequenc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 gene (TG) flank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two direct repeats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minivi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genic region (IR in the cas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omovirus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tovirus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hown is an T-DNA vector with a IR cassette that contains 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iven by a promoter of choice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roinfiltr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Upon expression of the viral Rep protein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som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molecules containing the sequenc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l be produced. Thes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som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molecules will be replicated by the action of Rep, and accumulate to high levels of mRNA and proteins in the cell. LB and RB indicate the T-DNA left and right border, respectively. IR, intergenic region; P, promoter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, target gene; 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minator; TP, target protei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 that the Rep protein does not need to be included in the same T-DNA, and can instead be provided independently via co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roinfiltr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is study.</a:t>
            </a:r>
          </a:p>
        </p:txBody>
      </p:sp>
      <p:grpSp>
        <p:nvGrpSpPr>
          <p:cNvPr id="5" name="그룹 4"/>
          <p:cNvGrpSpPr/>
          <p:nvPr/>
        </p:nvGrpSpPr>
        <p:grpSpPr>
          <a:xfrm>
            <a:off x="885045" y="3077074"/>
            <a:ext cx="5069116" cy="4024530"/>
            <a:chOff x="1404442" y="1285852"/>
            <a:chExt cx="5069116" cy="4024530"/>
          </a:xfrm>
        </p:grpSpPr>
        <p:grpSp>
          <p:nvGrpSpPr>
            <p:cNvPr id="6" name="그룹 5"/>
            <p:cNvGrpSpPr/>
            <p:nvPr/>
          </p:nvGrpSpPr>
          <p:grpSpPr>
            <a:xfrm>
              <a:off x="1404442" y="1285852"/>
              <a:ext cx="5069116" cy="4024530"/>
              <a:chOff x="1404442" y="1285852"/>
              <a:chExt cx="5069116" cy="4024530"/>
            </a:xfrm>
          </p:grpSpPr>
          <p:grpSp>
            <p:nvGrpSpPr>
              <p:cNvPr id="8" name="그룹 7"/>
              <p:cNvGrpSpPr/>
              <p:nvPr/>
            </p:nvGrpSpPr>
            <p:grpSpPr>
              <a:xfrm>
                <a:off x="1404442" y="1285852"/>
                <a:ext cx="2589540" cy="446284"/>
                <a:chOff x="1404442" y="1285852"/>
                <a:chExt cx="2589540" cy="446284"/>
              </a:xfrm>
            </p:grpSpPr>
            <p:grpSp>
              <p:nvGrpSpPr>
                <p:cNvPr id="175" name="그룹 174"/>
                <p:cNvGrpSpPr/>
                <p:nvPr/>
              </p:nvGrpSpPr>
              <p:grpSpPr>
                <a:xfrm>
                  <a:off x="3436382" y="1291270"/>
                  <a:ext cx="341984" cy="380162"/>
                  <a:chOff x="2179737" y="1026591"/>
                  <a:chExt cx="460692" cy="380162"/>
                </a:xfrm>
              </p:grpSpPr>
              <p:pic>
                <p:nvPicPr>
                  <p:cNvPr id="191" name="그림 190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2179737" y="1026591"/>
                    <a:ext cx="460692" cy="313422"/>
                  </a:xfrm>
                  <a:prstGeom prst="rect">
                    <a:avLst/>
                  </a:prstGeom>
                </p:spPr>
              </p:pic>
              <p:sp>
                <p:nvSpPr>
                  <p:cNvPr id="192" name="TextBox 191"/>
                  <p:cNvSpPr txBox="1"/>
                  <p:nvPr/>
                </p:nvSpPr>
                <p:spPr>
                  <a:xfrm>
                    <a:off x="2196114" y="1027250"/>
                    <a:ext cx="32733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3" name="직사각형 192"/>
                  <p:cNvSpPr/>
                  <p:nvPr/>
                </p:nvSpPr>
                <p:spPr>
                  <a:xfrm>
                    <a:off x="2369091" y="1235299"/>
                    <a:ext cx="95973" cy="9673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4" name="직사각형 193"/>
                  <p:cNvSpPr/>
                  <p:nvPr/>
                </p:nvSpPr>
                <p:spPr>
                  <a:xfrm>
                    <a:off x="2273198" y="1299069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76" name="그룹 175"/>
                <p:cNvGrpSpPr/>
                <p:nvPr/>
              </p:nvGrpSpPr>
              <p:grpSpPr>
                <a:xfrm>
                  <a:off x="1644415" y="1285852"/>
                  <a:ext cx="330793" cy="380162"/>
                  <a:chOff x="2179737" y="1026591"/>
                  <a:chExt cx="460692" cy="380162"/>
                </a:xfrm>
              </p:grpSpPr>
              <p:pic>
                <p:nvPicPr>
                  <p:cNvPr id="187" name="그림 186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2179737" y="1026591"/>
                    <a:ext cx="460692" cy="313422"/>
                  </a:xfrm>
                  <a:prstGeom prst="rect">
                    <a:avLst/>
                  </a:prstGeom>
                </p:spPr>
              </p:pic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2191755" y="1027250"/>
                    <a:ext cx="32733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9" name="직사각형 188"/>
                  <p:cNvSpPr/>
                  <p:nvPr/>
                </p:nvSpPr>
                <p:spPr>
                  <a:xfrm>
                    <a:off x="2369091" y="1235299"/>
                    <a:ext cx="95973" cy="9673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0" name="직사각형 189"/>
                  <p:cNvSpPr/>
                  <p:nvPr/>
                </p:nvSpPr>
                <p:spPr>
                  <a:xfrm>
                    <a:off x="2273198" y="1299069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cxnSp>
              <p:nvCxnSpPr>
                <p:cNvPr id="177" name="직선 연결선 176"/>
                <p:cNvCxnSpPr/>
                <p:nvPr/>
              </p:nvCxnSpPr>
              <p:spPr>
                <a:xfrm flipV="1">
                  <a:off x="1563447" y="1549767"/>
                  <a:ext cx="2314354" cy="124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8" name="직사각형 177"/>
                <p:cNvSpPr/>
                <p:nvPr/>
              </p:nvSpPr>
              <p:spPr>
                <a:xfrm>
                  <a:off x="2586023" y="1423581"/>
                  <a:ext cx="558569" cy="233103"/>
                </a:xfrm>
                <a:prstGeom prst="rect">
                  <a:avLst/>
                </a:prstGeom>
                <a:solidFill>
                  <a:srgbClr val="5AC31F"/>
                </a:solidFill>
                <a:ln w="12700" cap="flat" cmpd="sng" algn="ctr">
                  <a:solidFill>
                    <a:schemeClr val="tx1"/>
                  </a:solidFill>
                  <a:prstDash val="solid"/>
                  <a:miter lim="800000"/>
                </a:ln>
                <a:effectLst/>
              </p:spPr>
              <p:txBody>
                <a:bodyPr lIns="33000" rIns="3300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  TG 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직사각형 178"/>
                <p:cNvSpPr/>
                <p:nvPr/>
              </p:nvSpPr>
              <p:spPr>
                <a:xfrm>
                  <a:off x="3125542" y="1423187"/>
                  <a:ext cx="243973" cy="240187"/>
                </a:xfrm>
                <a:prstGeom prst="rect">
                  <a:avLst/>
                </a:prstGeom>
                <a:solidFill>
                  <a:sysClr val="window" lastClr="FFFFFF">
                    <a:lumMod val="50000"/>
                  </a:sys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33000" rIns="3300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T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오른쪽 화살표 179"/>
                <p:cNvSpPr/>
                <p:nvPr/>
              </p:nvSpPr>
              <p:spPr>
                <a:xfrm>
                  <a:off x="2017431" y="1361708"/>
                  <a:ext cx="557381" cy="370428"/>
                </a:xfrm>
                <a:prstGeom prst="rightArrow">
                  <a:avLst>
                    <a:gd name="adj1" fmla="val 61382"/>
                    <a:gd name="adj2" fmla="val 35773"/>
                  </a:avLst>
                </a:prstGeom>
                <a:solidFill>
                  <a:schemeClr val="accent1">
                    <a:lumMod val="75000"/>
                  </a:scheme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0" rIns="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     P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81" name="그룹 180"/>
                <p:cNvGrpSpPr/>
                <p:nvPr/>
              </p:nvGrpSpPr>
              <p:grpSpPr>
                <a:xfrm>
                  <a:off x="3757547" y="1380757"/>
                  <a:ext cx="236435" cy="339540"/>
                  <a:chOff x="4334542" y="1220748"/>
                  <a:chExt cx="220935" cy="307777"/>
                </a:xfrm>
              </p:grpSpPr>
              <p:sp>
                <p:nvSpPr>
                  <p:cNvPr id="185" name="직사각형 184"/>
                  <p:cNvSpPr/>
                  <p:nvPr/>
                </p:nvSpPr>
                <p:spPr>
                  <a:xfrm>
                    <a:off x="4401450" y="1244798"/>
                    <a:ext cx="100183" cy="23447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00"/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4334542" y="1220748"/>
                    <a:ext cx="22093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</a:t>
                    </a:r>
                  </a:p>
                  <a:p>
                    <a:r>
                      <a:rPr lang="en-US" sz="7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  <p:grpSp>
              <p:nvGrpSpPr>
                <p:cNvPr id="182" name="그룹 181"/>
                <p:cNvGrpSpPr/>
                <p:nvPr/>
              </p:nvGrpSpPr>
              <p:grpSpPr>
                <a:xfrm>
                  <a:off x="1404442" y="1386464"/>
                  <a:ext cx="341945" cy="307777"/>
                  <a:chOff x="869466" y="1213981"/>
                  <a:chExt cx="237876" cy="307777"/>
                </a:xfrm>
              </p:grpSpPr>
              <p:sp>
                <p:nvSpPr>
                  <p:cNvPr id="183" name="직사각형 182"/>
                  <p:cNvSpPr/>
                  <p:nvPr/>
                </p:nvSpPr>
                <p:spPr>
                  <a:xfrm>
                    <a:off x="908992" y="1244587"/>
                    <a:ext cx="76204" cy="24927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00"/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869466" y="1213981"/>
                    <a:ext cx="23787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</a:t>
                    </a:r>
                  </a:p>
                  <a:p>
                    <a:r>
                      <a:rPr lang="en-US" sz="7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</p:grpSp>
          <p:grpSp>
            <p:nvGrpSpPr>
              <p:cNvPr id="9" name="그룹 8"/>
              <p:cNvGrpSpPr/>
              <p:nvPr/>
            </p:nvGrpSpPr>
            <p:grpSpPr>
              <a:xfrm>
                <a:off x="4116965" y="1353694"/>
                <a:ext cx="2227773" cy="350264"/>
                <a:chOff x="4466359" y="580461"/>
                <a:chExt cx="2227773" cy="350264"/>
              </a:xfrm>
            </p:grpSpPr>
            <p:cxnSp>
              <p:nvCxnSpPr>
                <p:cNvPr id="165" name="직선 연결선 164"/>
                <p:cNvCxnSpPr>
                  <a:cxnSpLocks noChangeAspect="1"/>
                </p:cNvCxnSpPr>
                <p:nvPr/>
              </p:nvCxnSpPr>
              <p:spPr>
                <a:xfrm>
                  <a:off x="4532478" y="753429"/>
                  <a:ext cx="2012394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166" name="오른쪽 화살표 165"/>
                <p:cNvSpPr>
                  <a:spLocks noChangeAspect="1"/>
                </p:cNvSpPr>
                <p:nvPr/>
              </p:nvSpPr>
              <p:spPr>
                <a:xfrm>
                  <a:off x="4801711" y="580461"/>
                  <a:ext cx="459778" cy="350264"/>
                </a:xfrm>
                <a:prstGeom prst="rightArrow">
                  <a:avLst>
                    <a:gd name="adj1" fmla="val 61382"/>
                    <a:gd name="adj2" fmla="val 37196"/>
                  </a:avLst>
                </a:prstGeom>
                <a:solidFill>
                  <a:srgbClr val="2E6410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0" rIns="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</a:t>
                  </a: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P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7" name="직사각형 166"/>
                <p:cNvSpPr>
                  <a:spLocks noChangeAspect="1"/>
                </p:cNvSpPr>
                <p:nvPr/>
              </p:nvSpPr>
              <p:spPr>
                <a:xfrm flipH="1">
                  <a:off x="6024141" y="631138"/>
                  <a:ext cx="268115" cy="233276"/>
                </a:xfrm>
                <a:prstGeom prst="rect">
                  <a:avLst/>
                </a:prstGeom>
                <a:solidFill>
                  <a:sysClr val="window" lastClr="FFFFFF">
                    <a:lumMod val="50000"/>
                  </a:sys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33000" rIns="3300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T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직사각형 167"/>
                <p:cNvSpPr>
                  <a:spLocks noChangeAspect="1"/>
                </p:cNvSpPr>
                <p:nvPr/>
              </p:nvSpPr>
              <p:spPr>
                <a:xfrm>
                  <a:off x="5270549" y="638983"/>
                  <a:ext cx="756641" cy="229763"/>
                </a:xfrm>
                <a:prstGeom prst="rect">
                  <a:avLst/>
                </a:prstGeom>
                <a:solidFill>
                  <a:srgbClr val="ED7D31">
                    <a:lumMod val="75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lIns="33000" rIns="33000" rtlCol="0" anchor="ctr"/>
                <a:lstStyle/>
                <a:p>
                  <a:pPr defTabSz="419115" latinLnBrk="0">
                    <a:defRPr/>
                  </a:pPr>
                  <a:r>
                    <a:rPr lang="en-US" altLang="ko-KR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</a:t>
                  </a:r>
                  <a:r>
                    <a:rPr lang="en-US" altLang="ko-KR" sz="1000" b="1" kern="0" dirty="0" smtClean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      Rep </a:t>
                  </a:r>
                  <a:endParaRPr lang="ko-KR" altLang="en-US" sz="1000" b="1" kern="0" dirty="0">
                    <a:solidFill>
                      <a:prstClr val="white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69" name="그룹 168"/>
                <p:cNvGrpSpPr/>
                <p:nvPr/>
              </p:nvGrpSpPr>
              <p:grpSpPr>
                <a:xfrm>
                  <a:off x="6391234" y="611373"/>
                  <a:ext cx="302898" cy="282875"/>
                  <a:chOff x="6727999" y="585632"/>
                  <a:chExt cx="237876" cy="307777"/>
                </a:xfrm>
              </p:grpSpPr>
              <p:sp>
                <p:nvSpPr>
                  <p:cNvPr id="173" name="직사각형 172"/>
                  <p:cNvSpPr/>
                  <p:nvPr/>
                </p:nvSpPr>
                <p:spPr>
                  <a:xfrm>
                    <a:off x="6784351" y="617077"/>
                    <a:ext cx="76204" cy="24927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00"/>
                  </a:p>
                </p:txBody>
              </p:sp>
              <p:sp>
                <p:nvSpPr>
                  <p:cNvPr id="174" name="TextBox 173"/>
                  <p:cNvSpPr txBox="1"/>
                  <p:nvPr/>
                </p:nvSpPr>
                <p:spPr>
                  <a:xfrm>
                    <a:off x="6727999" y="585632"/>
                    <a:ext cx="23787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</a:t>
                    </a:r>
                  </a:p>
                  <a:p>
                    <a:r>
                      <a:rPr lang="en-US" sz="7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  <p:grpSp>
              <p:nvGrpSpPr>
                <p:cNvPr id="170" name="그룹 169"/>
                <p:cNvGrpSpPr/>
                <p:nvPr/>
              </p:nvGrpSpPr>
              <p:grpSpPr>
                <a:xfrm>
                  <a:off x="4466359" y="610539"/>
                  <a:ext cx="306093" cy="293234"/>
                  <a:chOff x="4308304" y="578223"/>
                  <a:chExt cx="234682" cy="307777"/>
                </a:xfrm>
              </p:grpSpPr>
              <p:sp>
                <p:nvSpPr>
                  <p:cNvPr id="171" name="직사각형 170"/>
                  <p:cNvSpPr/>
                  <p:nvPr/>
                </p:nvSpPr>
                <p:spPr>
                  <a:xfrm>
                    <a:off x="4356194" y="608829"/>
                    <a:ext cx="76204" cy="24927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00"/>
                  </a:p>
                </p:txBody>
              </p:sp>
              <p:sp>
                <p:nvSpPr>
                  <p:cNvPr id="172" name="TextBox 171"/>
                  <p:cNvSpPr txBox="1"/>
                  <p:nvPr/>
                </p:nvSpPr>
                <p:spPr>
                  <a:xfrm>
                    <a:off x="4308304" y="578223"/>
                    <a:ext cx="2346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</a:t>
                    </a:r>
                  </a:p>
                  <a:p>
                    <a:r>
                      <a:rPr lang="en-US" sz="7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</p:grpSp>
          <p:grpSp>
            <p:nvGrpSpPr>
              <p:cNvPr id="10" name="그룹 9"/>
              <p:cNvGrpSpPr/>
              <p:nvPr/>
            </p:nvGrpSpPr>
            <p:grpSpPr>
              <a:xfrm>
                <a:off x="2906422" y="1690724"/>
                <a:ext cx="669091" cy="374598"/>
                <a:chOff x="2840822" y="905274"/>
                <a:chExt cx="669091" cy="374598"/>
              </a:xfrm>
            </p:grpSpPr>
            <p:grpSp>
              <p:nvGrpSpPr>
                <p:cNvPr id="159" name="그룹 158"/>
                <p:cNvGrpSpPr/>
                <p:nvPr/>
              </p:nvGrpSpPr>
              <p:grpSpPr>
                <a:xfrm>
                  <a:off x="2973750" y="905274"/>
                  <a:ext cx="536163" cy="276999"/>
                  <a:chOff x="3126150" y="952899"/>
                  <a:chExt cx="536163" cy="276999"/>
                </a:xfrm>
              </p:grpSpPr>
              <p:sp>
                <p:nvSpPr>
                  <p:cNvPr id="161" name="TextBox 160"/>
                  <p:cNvSpPr txBox="1"/>
                  <p:nvPr/>
                </p:nvSpPr>
                <p:spPr>
                  <a:xfrm>
                    <a:off x="3126150" y="952899"/>
                    <a:ext cx="27283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</a:t>
                    </a:r>
                    <a:endPara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62" name="그룹 161"/>
                  <p:cNvGrpSpPr/>
                  <p:nvPr/>
                </p:nvGrpSpPr>
                <p:grpSpPr>
                  <a:xfrm>
                    <a:off x="3278875" y="973239"/>
                    <a:ext cx="383438" cy="230832"/>
                    <a:chOff x="2665691" y="1629018"/>
                    <a:chExt cx="383438" cy="230832"/>
                  </a:xfrm>
                </p:grpSpPr>
                <p:sp>
                  <p:nvSpPr>
                    <p:cNvPr id="163" name="타원 162"/>
                    <p:cNvSpPr/>
                    <p:nvPr/>
                  </p:nvSpPr>
                  <p:spPr>
                    <a:xfrm>
                      <a:off x="2716489" y="1659488"/>
                      <a:ext cx="269804" cy="184290"/>
                    </a:xfrm>
                    <a:prstGeom prst="ellipse">
                      <a:avLst/>
                    </a:prstGeom>
                    <a:solidFill>
                      <a:schemeClr val="accent2">
                        <a:lumMod val="75000"/>
                      </a:schemeClr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4" name="TextBox 163"/>
                    <p:cNvSpPr txBox="1"/>
                    <p:nvPr/>
                  </p:nvSpPr>
                  <p:spPr>
                    <a:xfrm>
                      <a:off x="2665691" y="1629018"/>
                      <a:ext cx="38343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</a:t>
                      </a:r>
                      <a:endParaRPr lang="en-US" sz="9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cxnSp>
              <p:nvCxnSpPr>
                <p:cNvPr id="160" name="직선 화살표 연결선 159"/>
                <p:cNvCxnSpPr/>
                <p:nvPr/>
              </p:nvCxnSpPr>
              <p:spPr>
                <a:xfrm>
                  <a:off x="2840822" y="947859"/>
                  <a:ext cx="292410" cy="33201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" name="그룹 10"/>
              <p:cNvGrpSpPr/>
              <p:nvPr/>
            </p:nvGrpSpPr>
            <p:grpSpPr>
              <a:xfrm>
                <a:off x="1550249" y="1694659"/>
                <a:ext cx="1230485" cy="718695"/>
                <a:chOff x="1484649" y="909209"/>
                <a:chExt cx="1230485" cy="718695"/>
              </a:xfrm>
            </p:grpSpPr>
            <p:cxnSp>
              <p:nvCxnSpPr>
                <p:cNvPr id="151" name="직선 화살표 연결선 150"/>
                <p:cNvCxnSpPr/>
                <p:nvPr/>
              </p:nvCxnSpPr>
              <p:spPr>
                <a:xfrm flipH="1">
                  <a:off x="2418828" y="938274"/>
                  <a:ext cx="296306" cy="32438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2" name="TextBox 151"/>
                <p:cNvSpPr txBox="1"/>
                <p:nvPr/>
              </p:nvSpPr>
              <p:spPr>
                <a:xfrm>
                  <a:off x="2060397" y="909209"/>
                  <a:ext cx="5212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− </a:t>
                  </a:r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p</a:t>
                  </a:r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53" name="그룹 152"/>
                <p:cNvGrpSpPr/>
                <p:nvPr/>
              </p:nvGrpSpPr>
              <p:grpSpPr>
                <a:xfrm>
                  <a:off x="1884266" y="1223637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57" name="타원 156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54" name="그룹 153"/>
                <p:cNvGrpSpPr/>
                <p:nvPr/>
              </p:nvGrpSpPr>
              <p:grpSpPr>
                <a:xfrm>
                  <a:off x="1484649" y="1381683"/>
                  <a:ext cx="509181" cy="246221"/>
                  <a:chOff x="1855691" y="1212879"/>
                  <a:chExt cx="509181" cy="246221"/>
                </a:xfrm>
              </p:grpSpPr>
              <p:sp>
                <p:nvSpPr>
                  <p:cNvPr id="155" name="타원 154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6" name="TextBox 155"/>
                  <p:cNvSpPr txBox="1"/>
                  <p:nvPr/>
                </p:nvSpPr>
                <p:spPr>
                  <a:xfrm>
                    <a:off x="1855691" y="1212879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12" name="그룹 11"/>
              <p:cNvGrpSpPr/>
              <p:nvPr/>
            </p:nvGrpSpPr>
            <p:grpSpPr>
              <a:xfrm>
                <a:off x="3125542" y="4284955"/>
                <a:ext cx="3348016" cy="1025427"/>
                <a:chOff x="3136142" y="3499505"/>
                <a:chExt cx="3348016" cy="1025427"/>
              </a:xfrm>
            </p:grpSpPr>
            <p:grpSp>
              <p:nvGrpSpPr>
                <p:cNvPr id="88" name="그룹 87"/>
                <p:cNvGrpSpPr/>
                <p:nvPr/>
              </p:nvGrpSpPr>
              <p:grpSpPr>
                <a:xfrm>
                  <a:off x="3773804" y="3578984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49" name="타원 148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0" name="TextBox 149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9" name="그룹 88"/>
                <p:cNvGrpSpPr/>
                <p:nvPr/>
              </p:nvGrpSpPr>
              <p:grpSpPr>
                <a:xfrm>
                  <a:off x="4282239" y="3514551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47" name="타원 146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8" name="TextBox 147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0" name="그룹 89"/>
                <p:cNvGrpSpPr/>
                <p:nvPr/>
              </p:nvGrpSpPr>
              <p:grpSpPr>
                <a:xfrm>
                  <a:off x="4155881" y="3748766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45" name="타원 144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6" name="TextBox 145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1" name="그룹 90"/>
                <p:cNvGrpSpPr/>
                <p:nvPr/>
              </p:nvGrpSpPr>
              <p:grpSpPr>
                <a:xfrm>
                  <a:off x="4684670" y="3711339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43" name="타원 142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4" name="TextBox 143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2" name="그룹 91"/>
                <p:cNvGrpSpPr/>
                <p:nvPr/>
              </p:nvGrpSpPr>
              <p:grpSpPr>
                <a:xfrm>
                  <a:off x="4015815" y="4010832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41" name="타원 140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2" name="TextBox 141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3" name="그룹 92"/>
                <p:cNvGrpSpPr/>
                <p:nvPr/>
              </p:nvGrpSpPr>
              <p:grpSpPr>
                <a:xfrm>
                  <a:off x="4487250" y="3950199"/>
                  <a:ext cx="509181" cy="256966"/>
                  <a:chOff x="1855691" y="1223637"/>
                  <a:chExt cx="509181" cy="246221"/>
                </a:xfrm>
              </p:grpSpPr>
              <p:sp>
                <p:nvSpPr>
                  <p:cNvPr id="139" name="타원 138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4" name="그룹 93"/>
                <p:cNvGrpSpPr/>
                <p:nvPr/>
              </p:nvGrpSpPr>
              <p:grpSpPr>
                <a:xfrm>
                  <a:off x="4000573" y="4278711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37" name="타원 136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8" name="TextBox 137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5" name="그룹 94"/>
                <p:cNvGrpSpPr/>
                <p:nvPr/>
              </p:nvGrpSpPr>
              <p:grpSpPr>
                <a:xfrm>
                  <a:off x="4945586" y="4046395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35" name="타원 134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6" name="그룹 95"/>
                <p:cNvGrpSpPr/>
                <p:nvPr/>
              </p:nvGrpSpPr>
              <p:grpSpPr>
                <a:xfrm>
                  <a:off x="5080801" y="3804737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33" name="타원 132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7" name="그룹 96"/>
                <p:cNvGrpSpPr/>
                <p:nvPr/>
              </p:nvGrpSpPr>
              <p:grpSpPr>
                <a:xfrm>
                  <a:off x="5455238" y="3933708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31" name="타원 130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8" name="그룹 97"/>
                <p:cNvGrpSpPr/>
                <p:nvPr/>
              </p:nvGrpSpPr>
              <p:grpSpPr>
                <a:xfrm>
                  <a:off x="4825768" y="3499505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29" name="타원 128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0" name="TextBox 129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9" name="그룹 98"/>
                <p:cNvGrpSpPr/>
                <p:nvPr/>
              </p:nvGrpSpPr>
              <p:grpSpPr>
                <a:xfrm>
                  <a:off x="5302846" y="3578984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27" name="타원 126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0" name="그룹 99"/>
                <p:cNvGrpSpPr/>
                <p:nvPr/>
              </p:nvGrpSpPr>
              <p:grpSpPr>
                <a:xfrm>
                  <a:off x="3300765" y="3681691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25" name="타원 124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1" name="그룹 100"/>
                <p:cNvGrpSpPr/>
                <p:nvPr/>
              </p:nvGrpSpPr>
              <p:grpSpPr>
                <a:xfrm>
                  <a:off x="3661663" y="3848903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23" name="타원 122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4" name="TextBox 123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2" name="그룹 101"/>
                <p:cNvGrpSpPr/>
                <p:nvPr/>
              </p:nvGrpSpPr>
              <p:grpSpPr>
                <a:xfrm>
                  <a:off x="3528371" y="4092131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21" name="타원 120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3" name="그룹 102"/>
                <p:cNvGrpSpPr/>
                <p:nvPr/>
              </p:nvGrpSpPr>
              <p:grpSpPr>
                <a:xfrm>
                  <a:off x="4480540" y="4203216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19" name="타원 118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0" name="TextBox 119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4" name="그룹 103"/>
                <p:cNvGrpSpPr/>
                <p:nvPr/>
              </p:nvGrpSpPr>
              <p:grpSpPr>
                <a:xfrm>
                  <a:off x="3136142" y="3924956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17" name="타원 116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8" name="TextBox 117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5" name="그룹 104"/>
                <p:cNvGrpSpPr/>
                <p:nvPr/>
              </p:nvGrpSpPr>
              <p:grpSpPr>
                <a:xfrm>
                  <a:off x="5974977" y="3918322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15" name="타원 114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6" name="TextBox 115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6" name="그룹 105"/>
                <p:cNvGrpSpPr/>
                <p:nvPr/>
              </p:nvGrpSpPr>
              <p:grpSpPr>
                <a:xfrm>
                  <a:off x="5644049" y="3735738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13" name="타원 112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4" name="TextBox 113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7" name="그룹 106"/>
                <p:cNvGrpSpPr/>
                <p:nvPr/>
              </p:nvGrpSpPr>
              <p:grpSpPr>
                <a:xfrm>
                  <a:off x="4971213" y="4258595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11" name="타원 110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2" name="TextBox 111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08" name="그룹 107"/>
                <p:cNvGrpSpPr/>
                <p:nvPr/>
              </p:nvGrpSpPr>
              <p:grpSpPr>
                <a:xfrm>
                  <a:off x="5443567" y="4171626"/>
                  <a:ext cx="509181" cy="246221"/>
                  <a:chOff x="1855691" y="1223637"/>
                  <a:chExt cx="509181" cy="246221"/>
                </a:xfrm>
              </p:grpSpPr>
              <p:sp>
                <p:nvSpPr>
                  <p:cNvPr id="109" name="타원 108"/>
                  <p:cNvSpPr/>
                  <p:nvPr/>
                </p:nvSpPr>
                <p:spPr>
                  <a:xfrm>
                    <a:off x="1879926" y="1235563"/>
                    <a:ext cx="484946" cy="2106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25400">
                    <a:solidFill>
                      <a:schemeClr val="accent6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0" name="TextBox 109"/>
                  <p:cNvSpPr txBox="1"/>
                  <p:nvPr/>
                </p:nvSpPr>
                <p:spPr>
                  <a:xfrm>
                    <a:off x="1855691" y="1223637"/>
                    <a:ext cx="4764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TP 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13" name="그룹 12"/>
              <p:cNvGrpSpPr/>
              <p:nvPr/>
            </p:nvGrpSpPr>
            <p:grpSpPr>
              <a:xfrm>
                <a:off x="2336696" y="2027349"/>
                <a:ext cx="4044359" cy="2067605"/>
                <a:chOff x="2271096" y="1241899"/>
                <a:chExt cx="4044359" cy="2067605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>
                  <a:off x="2271096" y="1504556"/>
                  <a:ext cx="696024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pisomal</a:t>
                  </a:r>
                  <a:endPara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NA</a:t>
                  </a:r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6" name="그룹 15"/>
                <p:cNvGrpSpPr/>
                <p:nvPr/>
              </p:nvGrpSpPr>
              <p:grpSpPr>
                <a:xfrm>
                  <a:off x="2931083" y="1241899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80" name="그림 79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2" name="직사각형 81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3" name="모서리가 둥근 직사각형 82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4" name="오른쪽 화살표 83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5" name="직사각형 84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6" name="직사각형 85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7" name="직사각형 86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7" name="그룹 16"/>
                <p:cNvGrpSpPr/>
                <p:nvPr/>
              </p:nvGrpSpPr>
              <p:grpSpPr>
                <a:xfrm>
                  <a:off x="3188072" y="2004805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72" name="그림 71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직사각형 73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5" name="모서리가 둥근 직사각형 74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6" name="오른쪽 화살표 75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직사각형 76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8" name="직사각형 77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9" name="직사각형 78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8" name="그룹 17"/>
                <p:cNvGrpSpPr/>
                <p:nvPr/>
              </p:nvGrpSpPr>
              <p:grpSpPr>
                <a:xfrm>
                  <a:off x="3591946" y="2623482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64" name="그림 63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직사각형 65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7" name="모서리가 둥근 직사각형 66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8" name="오른쪽 화살표 67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9" name="직사각형 68"/>
                  <p:cNvSpPr/>
                  <p:nvPr/>
                </p:nvSpPr>
                <p:spPr>
                  <a:xfrm>
                    <a:off x="2070914" y="3418235"/>
                    <a:ext cx="106751" cy="160329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0" name="직사각형 69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1" name="직사각형 70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9" name="그룹 18"/>
                <p:cNvGrpSpPr/>
                <p:nvPr/>
              </p:nvGrpSpPr>
              <p:grpSpPr>
                <a:xfrm>
                  <a:off x="3767599" y="1527198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56" name="그림 55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직사각형 57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9" name="모서리가 둥근 직사각형 58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0" name="오른쪽 화살표 59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1" name="직사각형 60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2" name="직사각형 61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" name="직사각형 62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20" name="그룹 19"/>
                <p:cNvGrpSpPr/>
                <p:nvPr/>
              </p:nvGrpSpPr>
              <p:grpSpPr>
                <a:xfrm>
                  <a:off x="4190194" y="2168895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48" name="그림 47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직사각형 49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1" name="모서리가 둥근 직사각형 50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2" name="오른쪽 화살표 51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" name="직사각형 52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" name="직사각형 53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직사각형 54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21" name="그룹 20"/>
                <p:cNvGrpSpPr/>
                <p:nvPr/>
              </p:nvGrpSpPr>
              <p:grpSpPr>
                <a:xfrm>
                  <a:off x="5460013" y="2034190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40" name="그림 39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" name="직사각형 41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3" name="모서리가 둥근 직사각형 42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4" name="오른쪽 화살표 43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직사각형 44"/>
                  <p:cNvSpPr/>
                  <p:nvPr/>
                </p:nvSpPr>
                <p:spPr>
                  <a:xfrm>
                    <a:off x="2077027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6" name="직사각형 45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직사각형 46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22" name="그룹 21"/>
                <p:cNvGrpSpPr/>
                <p:nvPr/>
              </p:nvGrpSpPr>
              <p:grpSpPr>
                <a:xfrm>
                  <a:off x="4881086" y="2569136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32" name="그림 31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직사각형 33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5" name="모서리가 둥근 직사각형 34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6" name="오른쪽 화살표 35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7" name="직사각형 36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" name="직사각형 37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9" name="직사각형 38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23" name="그룹 22"/>
                <p:cNvGrpSpPr/>
                <p:nvPr/>
              </p:nvGrpSpPr>
              <p:grpSpPr>
                <a:xfrm>
                  <a:off x="4740872" y="1633481"/>
                  <a:ext cx="855442" cy="686022"/>
                  <a:chOff x="1395660" y="2966130"/>
                  <a:chExt cx="855442" cy="686022"/>
                </a:xfrm>
              </p:grpSpPr>
              <p:pic>
                <p:nvPicPr>
                  <p:cNvPr id="24" name="그림 23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-1" r="4734" b="18092"/>
                  <a:stretch/>
                </p:blipFill>
                <p:spPr>
                  <a:xfrm>
                    <a:off x="1676678" y="2966130"/>
                    <a:ext cx="294119" cy="343499"/>
                  </a:xfrm>
                  <a:prstGeom prst="rect">
                    <a:avLst/>
                  </a:prstGeom>
                </p:spPr>
              </p:pic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1676831" y="2978840"/>
                    <a:ext cx="31290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R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직사각형 25"/>
                  <p:cNvSpPr/>
                  <p:nvPr/>
                </p:nvSpPr>
                <p:spPr>
                  <a:xfrm>
                    <a:off x="1727451" y="3249635"/>
                    <a:ext cx="293611" cy="10768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7" name="모서리가 둥근 직사각형 26"/>
                  <p:cNvSpPr/>
                  <p:nvPr/>
                </p:nvSpPr>
                <p:spPr>
                  <a:xfrm>
                    <a:off x="1395660" y="3239386"/>
                    <a:ext cx="855442" cy="26177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8" name="오른쪽 화살표 27"/>
                  <p:cNvSpPr/>
                  <p:nvPr/>
                </p:nvSpPr>
                <p:spPr>
                  <a:xfrm>
                    <a:off x="1443285" y="3353462"/>
                    <a:ext cx="314178" cy="298690"/>
                  </a:xfrm>
                  <a:prstGeom prst="rightArrow">
                    <a:avLst>
                      <a:gd name="adj1" fmla="val 50000"/>
                      <a:gd name="adj2" fmla="val 58094"/>
                    </a:avLst>
                  </a:prstGeom>
                  <a:solidFill>
                    <a:schemeClr val="accent1">
                      <a:lumMod val="75000"/>
                    </a:schemeClr>
                  </a:solidFill>
                  <a:ln w="12700">
                    <a:solidFill>
                      <a:sysClr val="windowText" lastClr="000000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50" b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endParaRPr lang="en-US" sz="105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직사각형 28"/>
                  <p:cNvSpPr/>
                  <p:nvPr/>
                </p:nvSpPr>
                <p:spPr>
                  <a:xfrm>
                    <a:off x="2086552" y="3417715"/>
                    <a:ext cx="102256" cy="155666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</a:t>
                    </a:r>
                    <a:endPara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0" name="직사각형 29"/>
                  <p:cNvSpPr/>
                  <p:nvPr/>
                </p:nvSpPr>
                <p:spPr>
                  <a:xfrm>
                    <a:off x="1768443" y="3417715"/>
                    <a:ext cx="307130" cy="154976"/>
                  </a:xfrm>
                  <a:prstGeom prst="rect">
                    <a:avLst/>
                  </a:prstGeom>
                  <a:solidFill>
                    <a:srgbClr val="5AC31F"/>
                  </a:solidFill>
                  <a:ln w="12700" cap="flat" cmpd="sng" algn="ctr">
                    <a:solidFill>
                      <a:schemeClr val="tx1"/>
                    </a:solidFill>
                    <a:prstDash val="solid"/>
                    <a:miter lim="800000"/>
                  </a:ln>
                  <a:effectLst/>
                </p:spPr>
                <p:txBody>
                  <a:bodyPr lIns="33000" rIns="33000" rtlCol="0" anchor="ctr"/>
                  <a:lstStyle/>
                  <a:p>
                    <a:pPr defTabSz="419115" latinLnBrk="0">
                      <a:defRPr/>
                    </a:pPr>
                    <a:r>
                      <a:rPr lang="en-US" altLang="ko-KR" sz="1000" b="1" kern="0" dirty="0" smtClean="0">
                        <a:solidFill>
                          <a:prstClr val="white"/>
                        </a:solidFill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rPr>
                      <a:t> TG</a:t>
                    </a:r>
                    <a:endParaRPr lang="ko-KR" altLang="en-US" sz="1000" b="1" kern="0" dirty="0">
                      <a:solidFill>
                        <a:prstClr val="white"/>
                      </a:solidFill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" name="직사각형 30"/>
                  <p:cNvSpPr/>
                  <p:nvPr/>
                </p:nvSpPr>
                <p:spPr>
                  <a:xfrm>
                    <a:off x="1790701" y="3165708"/>
                    <a:ext cx="64524" cy="1108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cxnSp>
            <p:nvCxnSpPr>
              <p:cNvPr id="14" name="직선 화살표 연결선 13"/>
              <p:cNvCxnSpPr/>
              <p:nvPr/>
            </p:nvCxnSpPr>
            <p:spPr>
              <a:xfrm>
                <a:off x="4744042" y="4011841"/>
                <a:ext cx="0" cy="2218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" name="구부러진 연결선 6"/>
            <p:cNvCxnSpPr/>
            <p:nvPr/>
          </p:nvCxnSpPr>
          <p:spPr>
            <a:xfrm rot="5400000">
              <a:off x="4334487" y="911016"/>
              <a:ext cx="184501" cy="1723963"/>
            </a:xfrm>
            <a:prstGeom prst="curvedConnector2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45827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그룹 17"/>
          <p:cNvGrpSpPr/>
          <p:nvPr/>
        </p:nvGrpSpPr>
        <p:grpSpPr>
          <a:xfrm>
            <a:off x="82550" y="6661150"/>
            <a:ext cx="6661150" cy="1968500"/>
            <a:chOff x="82550" y="2294890"/>
            <a:chExt cx="6661150" cy="1968500"/>
          </a:xfrm>
        </p:grpSpPr>
        <p:sp>
          <p:nvSpPr>
            <p:cNvPr id="19" name="직사각형 18"/>
            <p:cNvSpPr/>
            <p:nvPr/>
          </p:nvSpPr>
          <p:spPr>
            <a:xfrm>
              <a:off x="85409" y="4110990"/>
              <a:ext cx="2210116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83185" y="4077970"/>
            <a:ext cx="6661150" cy="1968500"/>
            <a:chOff x="82550" y="2294890"/>
            <a:chExt cx="6661150" cy="1968500"/>
          </a:xfrm>
        </p:grpSpPr>
        <p:sp>
          <p:nvSpPr>
            <p:cNvPr id="16" name="직사각형 15"/>
            <p:cNvSpPr/>
            <p:nvPr/>
          </p:nvSpPr>
          <p:spPr>
            <a:xfrm>
              <a:off x="85409" y="4110990"/>
              <a:ext cx="2210116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82550" y="1182370"/>
            <a:ext cx="6661150" cy="2736850"/>
            <a:chOff x="82550" y="2294890"/>
            <a:chExt cx="6661150" cy="2736850"/>
          </a:xfrm>
        </p:grpSpPr>
        <p:sp>
          <p:nvSpPr>
            <p:cNvPr id="7" name="직사각형 6"/>
            <p:cNvSpPr/>
            <p:nvPr/>
          </p:nvSpPr>
          <p:spPr>
            <a:xfrm>
              <a:off x="6565900" y="4110990"/>
              <a:ext cx="177800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82550" y="4879340"/>
              <a:ext cx="4222750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82550" y="4263390"/>
              <a:ext cx="6661150" cy="61595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85409" y="4110990"/>
              <a:ext cx="2210116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4" name="직사각형 3"/>
          <p:cNvSpPr/>
          <p:nvPr/>
        </p:nvSpPr>
        <p:spPr>
          <a:xfrm>
            <a:off x="0" y="975271"/>
            <a:ext cx="6858000" cy="83715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) TYLCV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3</a:t>
            </a:r>
          </a:p>
          <a:p>
            <a:pPr algn="just" fontAlgn="base" latinLnBrk="1"/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cctcgtttatttaatatatatgccaaaaattatttcctaacatatcccaattgttctctctctaaagaggaagcactttcccaattaaaaaacctagaaaccccaacaaataaaaaatacatcaaagtttgcaaagaactccacgaga</a:t>
            </a:r>
            <a:r>
              <a:rPr lang="en-US" altLang="ko-KR" sz="1000" u="sng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gggaaccacatctccatgtgcttatccaattcgaaggcaaataccaatgtaagaaccaacggttcttcgacctggtatccccaaacaggtcagcacatttccatccgaacattcaggcagctaagagctcaacagatgtcaagacctacgtggagaaagacggagacttcattgattttggagttttccaaatcgatggcagatcagctagaggaggtcagcaatctgccaacgacgcatatgccgaagcactcaattcaggcagtaaatccgaggccctcaatatattaa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agagaaggccccaaaggactatattttacaatttcataatttaagttcaaatttagataggatttttagtcctcctttagaagtttatgtttctccatttctttcttcttcttttaatcaagttccagatgaacttgaagagtgggtcgccgagaacgtcgt</a:t>
            </a:r>
            <a:r>
              <a:rPr lang="en-US" altLang="ko-KR" sz="1000" kern="0" dirty="0" smtClean="0">
                <a:solidFill>
                  <a:srgbClr val="FF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AGTT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ctgcgcggccat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GGC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ataagtattgtcattgagggtgatagcagaacagggaaaacaatgtgggc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GAGT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ggcccacataattatttatgtggacat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tagacctaagcccaaaggtgtacagcaatgatgcatggtacaacgtcattgatgacgtagacccgcattatttaaagcacttcaaggaatttatgggggcccaaagggactggcaaagcaacacaaagtacgggaagcccattcaaattaaagggggaattcccactatcttcctctgcaatcaaggacctacctcctcatataaggaatatctagacgaagaaaaaaacatatccttgaaaaattggactctcaaga</a:t>
            </a:r>
            <a:r>
              <a:rPr lang="en-US" altLang="ko-KR" sz="1000" kern="0" dirty="0" smtClean="0">
                <a:solidFill>
                  <a:srgbClr val="00B0F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caaccttcgtcaccctctacgagccactgttcgcaagtatcaatcaaggtccaacacaaaatagccaagaagaaaccaataaggcgtaagcgtgtagacctagactgtggctgctcatactacctccacctcaactgcaataatcatggattcacgcacaggggaactcatcactgctcctcaggcagagaatggcgtttttatctgggagataaacaatcccctctatttcaagataacagaacacagccagaggccatttctaatgaaccacgacatcatttccattcagataagattcaaccacaacatcaggaaggtcatggggattcacaaatgttttctcaacttccgaatttggacgacattacatcctcagactggtcatttcttaagagtatttag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atgaagttcttaagtatttagatagtcttggtgtaatttccattaacaatgtaatcagatcagttgatcatgtattgtatgatgtacttgaaaacacaataaatgtaacagaaactcatgatataaaatataaattttattaa</a:t>
            </a: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) TYLCV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kern="0" dirty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gcctcgtttatttaatatatatgccaaaaattatttcctaacatatcccaattgttctctctctaaagaggaagcactttcccaattaaaaaacctagaaaccccaacaaataaaaaatacatcaaagtttgcaaagaactccacgaga</a:t>
            </a:r>
            <a:r>
              <a:rPr lang="en-US" altLang="ko-KR" sz="1000" u="sng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gggaaccacatctccatgtgcttatccaattcgaaggcaaataccaatgtaagaaccaacggttcttcgacctggtatccccaaacaggtcagcacatttccatccgaacattcaggcagctaagagctcaacagatgtcaagacctacgtggagaaagacggagacttcattgattttggagttttccaaatcgatggcagatcagctagaggaggtcagcaatctgccaacgacgcatatgccgaagcactcaattcaggcagtaaatccgaggccctcaatatattaa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agagaaggccccaaaggactatattttacaatttcataatttaagttcaaatttagataggatttttagtcctcctttagaagtttatgtttctccatttctttcttcttcttttaatcaagttccagatgaacttgaagagtgggtcgccgagaacgtcgt</a:t>
            </a:r>
            <a:r>
              <a:rPr lang="en-US" altLang="ko-KR" sz="1000" kern="0" dirty="0" smtClean="0">
                <a:solidFill>
                  <a:srgbClr val="FF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AGTT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ctgcgcggccat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GGC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ataagtattgtcattgagggtgatagcagaacagggaaaacaatgtgggc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GAGT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ggcccacataattatttatgtggacat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tagacctaagcccaaaggtgtacagcaatgatgcatggtacaacgtcattgatgacgtagacccgcattatttaaagcacttcaaggaatttatgggggcccaaagggactggcaaagcaacacaaagtacgggaagcccattcaaattaaagggggaattcccactatcttcctctgcaatcaaggacctacctcctcatataaggaatatctagacgaagaaaaaaacatatccttgaaaaattggactctcaaga</a:t>
            </a:r>
            <a:r>
              <a:rPr lang="en-US" altLang="ko-KR" sz="1000" kern="0" dirty="0" smtClean="0">
                <a:solidFill>
                  <a:srgbClr val="00B0F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caaccttcgtcaccctctacgagccactgttcgcaagtatcaatcaaggtccaacacaaaatagccaagaagaaaccaataaggcgtaagcgtgtagacctagactgtggctgctcatactacctccacctcaactgcaataatca</a:t>
            </a:r>
            <a:r>
              <a:rPr lang="en-US" altLang="ko-KR" sz="1000" b="1" kern="0" dirty="0" smtClean="0">
                <a:solidFill>
                  <a:srgbClr val="7030A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</a:t>
            </a:r>
            <a:r>
              <a:rPr lang="en-US" altLang="ko-KR" sz="1000" kern="0" dirty="0" smtClean="0">
                <a:solidFill>
                  <a:srgbClr val="00B0F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gattcacgcacaggggaactcatcactgctcctcaggcagagaatggcgtttttatctgggagataaacaatcccctctatttcaagataacagaacacagccagaggccatttctaatgaaccacgacatcatttccattcagataagattcaaccacaacatcaggaaggtcatggggattcacaaatgttttctcaacttccgaatttggacgacattacatcctcagactggtcatttcttaagagtatttag</a:t>
            </a: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)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YLCV </a:t>
            </a:r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cctcgtttatttaatatatatgccaaaaattatttcctaacatatcccaattgttctctctctaaagaggaagcactttcccaattaaaaaacctagaaaccccaacaaataaaaaatacatcaaagtttgcaaagaactccacgaga</a:t>
            </a:r>
            <a:r>
              <a:rPr lang="en-US" altLang="ko-KR" sz="1000" u="sng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tggggaaccacatctccatgtgcttatccaattcgaaggcaaataccaatgtaagaaccaacggttcttcgacctggtatccccaaacaggtcagcacatttccatccgaacattcaggcagctaagagctcaacagatgtcaagacctacgtggagaaagacggagacttcattgattttggagttttccaaatcgatggcagatcagctagaggaggtcagcaatctgccaacgacgcatatgccgaagcactcaattcaggcagtaaatccgaggccctcaatatattaa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agagaaggccccaaaggactatattttacaatttcataatttaagttcaaatttagataggatttttagtcctcctttagaagtttatgtttctccatttctttcttcttcttttaatcaagttccagatgaacttgaagagtgggtcgccgagaacgtcgt</a:t>
            </a:r>
            <a:r>
              <a:rPr lang="en-US" altLang="ko-KR" sz="1000" kern="0" dirty="0" smtClean="0">
                <a:solidFill>
                  <a:srgbClr val="FF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AGTT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ctgcgcggccat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GGCC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ataagtattgtcattgagggtgatagcagaacagggaaaacaatgtgggc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</a:t>
            </a:r>
            <a:r>
              <a:rPr lang="en-US" altLang="ko-KR" sz="1000" kern="0" dirty="0" smtClean="0">
                <a:solidFill>
                  <a:srgbClr val="0000FF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GAGT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ggcccacataattatttatgtggacat</a:t>
            </a:r>
            <a:r>
              <a:rPr lang="en-US" altLang="ko-KR" sz="1000" kern="0" dirty="0" smtClean="0">
                <a:solidFill>
                  <a:srgbClr val="0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tagacctaagcccaaaggtgtacagcaatgatgcatggtacaacgtcattgatgacgtagacccgcattatttaaagcacttcaaggaatttatgggggcccaaagggactggcaaagcaacacaaagtacgggaagcccattcaaattaaagggggaattcccactatcttcctctgcaatcaaggacctacctcctcatataaggaatatctagacgaagaaaaaaacatatccttgaaaaattggactctcaaga</a:t>
            </a:r>
            <a:r>
              <a:rPr lang="en-US" altLang="ko-KR" sz="1000" kern="0" dirty="0" smtClean="0"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a</a:t>
            </a:r>
            <a:r>
              <a:rPr lang="en-US" altLang="ko-KR" sz="1000" b="1" kern="0" dirty="0" smtClean="0">
                <a:solidFill>
                  <a:srgbClr val="7030A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</a:t>
            </a:r>
            <a:r>
              <a:rPr lang="en-US" altLang="ko-KR" sz="1000" kern="0" dirty="0" smtClean="0"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caaccttcgtcaccctctacgagccactgttcgcaagtatcaatcaaggtccaacacaaaatagccaagaagaaaccaataaggcgtaa</a:t>
            </a:r>
            <a:endParaRPr lang="en-US" altLang="ko-KR" sz="1000" kern="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 fontAlgn="base" latinLnBrk="1"/>
            <a:endParaRPr lang="en-US" altLang="ko-KR" sz="1000" kern="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400" kern="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piI</a:t>
            </a:r>
            <a:r>
              <a:rPr lang="en-US" altLang="ko-KR" sz="1400" kern="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400" kern="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saI</a:t>
            </a:r>
            <a:r>
              <a:rPr lang="en-US" altLang="ko-KR" sz="1400" kern="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nzyme </a:t>
            </a:r>
            <a:r>
              <a:rPr lang="en-US" altLang="ko-KR" sz="1400" kern="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ites </a:t>
            </a:r>
            <a:r>
              <a:rPr lang="en-US" altLang="ko-KR" sz="1400" kern="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eed to add at both 5’ and 3’-end</a:t>
            </a:r>
          </a:p>
          <a:p>
            <a:pPr algn="just" fontAlgn="base" latinLnBrk="1"/>
            <a:endParaRPr lang="en-US" altLang="ko-KR" sz="1400" kern="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0" y="0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overlapped ORF sequences of gen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with the viral DNA replication (C1, C2, C3 and C4) 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YLCV use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is study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) TYLCV C1, C2 and C3 ORFs. b)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LCV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 an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Fs. c)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LCV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 ORF. C1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le orange background), C2 (sky blue characters), C3 (gray background) and C4 (underlined characters in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le orang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kground)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F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YLCV. Red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lue uppercase letters represent the modified sequences from th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sz="1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i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sa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out alteration of amino acid, respectively. Purple bold uppercase letter indicates a modified start codon without alteration of amino acid.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175122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그룹 27"/>
          <p:cNvGrpSpPr/>
          <p:nvPr/>
        </p:nvGrpSpPr>
        <p:grpSpPr>
          <a:xfrm>
            <a:off x="82550" y="6836410"/>
            <a:ext cx="6661150" cy="1968500"/>
            <a:chOff x="82550" y="2294890"/>
            <a:chExt cx="6661150" cy="1968500"/>
          </a:xfrm>
        </p:grpSpPr>
        <p:sp>
          <p:nvSpPr>
            <p:cNvPr id="29" name="직사각형 28"/>
            <p:cNvSpPr/>
            <p:nvPr/>
          </p:nvSpPr>
          <p:spPr>
            <a:xfrm>
              <a:off x="85408" y="4110990"/>
              <a:ext cx="3667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직사각형 29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2" name="그룹 21"/>
          <p:cNvGrpSpPr/>
          <p:nvPr/>
        </p:nvGrpSpPr>
        <p:grpSpPr>
          <a:xfrm>
            <a:off x="82550" y="4077970"/>
            <a:ext cx="6661150" cy="1968500"/>
            <a:chOff x="82550" y="2294890"/>
            <a:chExt cx="6661150" cy="1968500"/>
          </a:xfrm>
        </p:grpSpPr>
        <p:sp>
          <p:nvSpPr>
            <p:cNvPr id="25" name="직사각형 24"/>
            <p:cNvSpPr/>
            <p:nvPr/>
          </p:nvSpPr>
          <p:spPr>
            <a:xfrm>
              <a:off x="85408" y="4110990"/>
              <a:ext cx="3667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직사각형 25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82549" y="1182370"/>
            <a:ext cx="6661151" cy="2736850"/>
            <a:chOff x="82549" y="2294890"/>
            <a:chExt cx="6661151" cy="2736850"/>
          </a:xfrm>
        </p:grpSpPr>
        <p:sp>
          <p:nvSpPr>
            <p:cNvPr id="8" name="직사각형 7"/>
            <p:cNvSpPr/>
            <p:nvPr/>
          </p:nvSpPr>
          <p:spPr>
            <a:xfrm>
              <a:off x="82549" y="4879340"/>
              <a:ext cx="4975225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82550" y="4422140"/>
              <a:ext cx="6661150" cy="4572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85408" y="4110990"/>
              <a:ext cx="3667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1" name="직사각형 20"/>
            <p:cNvSpPr/>
            <p:nvPr/>
          </p:nvSpPr>
          <p:spPr>
            <a:xfrm>
              <a:off x="701674" y="4271020"/>
              <a:ext cx="6042026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4" name="직사각형 3"/>
          <p:cNvSpPr/>
          <p:nvPr/>
        </p:nvSpPr>
        <p:spPr>
          <a:xfrm>
            <a:off x="0" y="975271"/>
            <a:ext cx="6858000" cy="80945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) HYVV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3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agagctgggcgtttctctttaaaagccaaaaattatttcctcacatacccacaatgctccatcgacaaaggtgaagccctaacccaattacaaaaattaaacacaccaactaacattaaattcataaggatctgcagagagctacatcaaa</a:t>
            </a:r>
            <a:r>
              <a:rPr lang="en-US" altLang="ko-KR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gagccctcatctccatgtcctcatccagttcgaggggaaatacaactgcacaaatcaacgattcttcgacctcgtatccccaaacaggtcagcacatttccatccaaacattcagggagctaaaagctcgtcagatgtcaagacctatatggagaaagacggagacatcgttgattttggagtgttccaggtcgatggaagatcagctagaggaggttgccagtctgccaacgacgcgtatgccgaggcaatcaactcaggatctaagtcatcggcactctgtatatt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gaaagctcccaaagattttgttttacaatttcataatttaaatagcaatttagataggatttttgctcctccgttggaggaatttgtttctccttttttatcttcttcatttgatcaagttccagagcaacttgaggaatgggctgccgagaacgtcagggattccgctgcgcggccatggaggcccattagcattgtgatagaaggtgatagcaggacagg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G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gtgggcca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T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tccacgtcataactacctttgcggccatcttgacttaagccccaaggtttacagcaatgaggcctggtacaacgtcattgatgacgtggatccccactatctaaagcactttaaagagttcatgggggcccaaagggactggcaaagcaacaccaagtacgggaaaccaattcaaattaaaggaggtatcccaacaatcttcctctgcaatccaggcccaacgtcatcatacaccgagtatttagacgaggacaagaatgctgccctaaaagcctgggcaattaaaa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caaccttcgtcaccctctacggcccactctactcaggtacccatcaaggtgcgacacagatcagagaagaggagagcacctcgccggaggaggattgatctgaactgcgggtgttctatttacgtcgcattggggtgtgcaaatcatggattcacgcacaggggacaccatcactgcagctcaggcaaggaatggcgcgtatacctggacagtgcccaatcccctatatttcaaaatcacgacacacgcgcaacggccattcaacatggatcaggatataataactttacagatacaattcaaccacaacctcaggaatcaactgcacatacacaagtgcttcctctctttcaagatttggactcgcttacatcctcagactttgcatttcttgagggtatttag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ctcaagtgttgaagtacttagataatttgggtgtaatatcaattaacaatgtaattagagcagtagatcatgtattgtataatgtattcgaaggaactgaatatgtacaacaatttacagatataaaatttaagctttattaa</a:t>
            </a:r>
            <a:endParaRPr lang="en-US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)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YVV</a:t>
            </a:r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agagctgggcgtttctctttaaaagccaaaaattatttcctcacatacccacaatgctccatcgacaaaggtgaagccctaacccaattacaaaaattaaacacaccaactaacattaaattcataaggatctgcagagagctacatcaaa</a:t>
            </a:r>
            <a:r>
              <a:rPr lang="en-US" altLang="ko-KR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gagccctcatctccatgtcctcatccagttcgaggggaaatacaactgcacaaatcaacgattcttcgacctcgtatccccaaacaggtcagcacatttccatccaaacattcagggagctaaaagctcgtcagatgtcaagacctatatggagaaagacggagacatcgttgattttggagtgttccaggtcgatggaagatcagctagaggaggttgccagtctgccaacgacgcgtatgccgaggcaatcaactcaggatctaagtcatcggcactctgtatatt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gaaagctcccaaagattttgttttacaatttcataatttaaatagcaatttagataggatttttgctcctccgttggaggaatttgtttctccttttttatcttcttcatttgatcaagttccagagcaacttgaggaatgggctgccgagaacgtcagggattccgctgcgcggccatggaggcccattagcattgtgatagaaggtgatagcaggacagg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G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gtgggcca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T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tccacgtcataactacctttgcggccatcttgacttaagccccaaggtttacagcaatgaggcctggtacaacgtcattgatgacgtggatccccactatctaaagcactttaaagagttcatgggggcccaaagggactggcaaagcaacaccaagtacgggaaaccaattcaaattaaaggaggtatcccaacaatcttcctctgcaatccaggcccaacgtcatcatacaccgagtatttagacgaggacaagaatgctgccctaaaagcctgggcaattaaaa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caaccttcgtcaccctctacggcccactctactcaggtacccatcaaggtgcgacacagatcagagaagaggagagcacctcgccggaggaggattgatctgaactgcgggtgttctatttacgtcgcattggggtgtgcaaatca</a:t>
            </a:r>
            <a:r>
              <a:rPr lang="en-US" altLang="ko-KR" sz="1000" b="1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ttcacgcacaggggacaccatcactgcagctcaggcaaggaatggcgcgtatacctggacagtgcccaatcccctatatttcaaaatcacgacacacgcgcaacggccattcaacatggatcaggatataataactttacagatacaattcaaccacaacctcaggaatcaactgcacatacacaagtgcttcctctctttcaagatttggactcgcttacatcctcagactttgcatttcttgagggtatttag</a:t>
            </a:r>
            <a:endParaRPr lang="en-US" altLang="ko-KR" sz="1000" kern="0" dirty="0" smtClean="0">
              <a:solidFill>
                <a:srgbClr val="00B0F0"/>
              </a:solidFill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)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YVV</a:t>
            </a:r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C1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agagctgggcgtttctctttaaaagccaaaaattatttcctcacatacccacaatgctccatcgacaaaggtgaagccctaacccaattacaaaaattaaacacaccaactaacattaaattcataaggatctgcagagagctacatcaaa</a:t>
            </a:r>
            <a:r>
              <a:rPr lang="en-US" altLang="ko-KR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gagccctcatctccatgtcctcatccagttcgaggggaaatacaactgcacaaatcaacgattcttcgacctcgtatccccaaacaggtcagcacatttccatccaaacattcagggagctaaaagctcgtcagatgtcaagacctatatggagaaagacggagacatcgttgattttggagtgttccaggtcgatggaagatcagctagaggaggttgccagtctgccaacgacgcgtatgccgaggcaatcaactcaggatctaagtcatcggcactctgtatatt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gaaagctcccaaagattttgttttacaatttcataatttaaatagcaatttagataggatttttgctcctccgttggaggaatttgtttctccttttttatcttcttcatttgatcaagttccagagcaacttgaggaatgggctgccgagaacgtcagggattccgctgcgcggccatggaggcccattagcattgtgatagaaggtgatagcaggacagg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G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gtgggcca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T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tccacgtcataactacctttgcggccatcttgacttaagccccaaggtttacagcaatgaggcctggtacaacgtcattgatgacgtggatccccactatctaaagcactttaaagagttcatgggggcccaaagggactggcaaagcaacaccaagtacgggaaaccaattcaaattaaaggaggtatcccaacaatcttcctctgcaatccaggcccaacgtcatcatacaccgagtatttagacgaggacaagaatgctgccctaaaagcctgggcaattaaaaa</a:t>
            </a:r>
            <a:r>
              <a:rPr lang="en-US" altLang="ko-KR" sz="1000" b="1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accttcgtcaccctctacggcccactctactcaggtacccatcaaggtgcgacacagatcagagaagaggagagcacctcgccggaggaggattga</a:t>
            </a:r>
            <a:endParaRPr lang="en-US" altLang="ko-KR" sz="1000" kern="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 fontAlgn="base" latinLnBrk="1"/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0" y="0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overlapped ORF sequences of gen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with the viral DNA replication (C1, C2, C3 and C4) 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VV use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is study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HYVV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, C2 and C3 ORFs. b) HYVV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and C2 ORFs. c) HYVV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ORF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le orange background), C2 (sky blue characters), C3 (gray background) and C4 (underlined characters in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le orang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kground)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F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VV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d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lue uppercase letters represent the modified sequences from th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sz="1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i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sa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out alteration of amino acid, respectively. Purple bold uppercase letter indicates a modified start codon without alteration of amino acid.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104682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그룹 29"/>
          <p:cNvGrpSpPr/>
          <p:nvPr/>
        </p:nvGrpSpPr>
        <p:grpSpPr>
          <a:xfrm>
            <a:off x="82550" y="6827163"/>
            <a:ext cx="6661150" cy="1968500"/>
            <a:chOff x="82550" y="2294890"/>
            <a:chExt cx="6661150" cy="1968500"/>
          </a:xfrm>
        </p:grpSpPr>
        <p:sp>
          <p:nvSpPr>
            <p:cNvPr id="31" name="직사각형 30"/>
            <p:cNvSpPr/>
            <p:nvPr/>
          </p:nvSpPr>
          <p:spPr>
            <a:xfrm>
              <a:off x="85408" y="4110990"/>
              <a:ext cx="2524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83185" y="4083963"/>
            <a:ext cx="6661150" cy="1968500"/>
            <a:chOff x="82550" y="2294890"/>
            <a:chExt cx="6661150" cy="1968500"/>
          </a:xfrm>
        </p:grpSpPr>
        <p:sp>
          <p:nvSpPr>
            <p:cNvPr id="25" name="직사각형 24"/>
            <p:cNvSpPr/>
            <p:nvPr/>
          </p:nvSpPr>
          <p:spPr>
            <a:xfrm>
              <a:off x="85408" y="4110990"/>
              <a:ext cx="2524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직사각형 25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82550" y="1182370"/>
            <a:ext cx="6661150" cy="2736850"/>
            <a:chOff x="82550" y="2294890"/>
            <a:chExt cx="6661150" cy="2736850"/>
          </a:xfrm>
        </p:grpSpPr>
        <p:sp>
          <p:nvSpPr>
            <p:cNvPr id="7" name="직사각형 6"/>
            <p:cNvSpPr/>
            <p:nvPr/>
          </p:nvSpPr>
          <p:spPr>
            <a:xfrm>
              <a:off x="4133850" y="4110990"/>
              <a:ext cx="2609850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82550" y="4879340"/>
              <a:ext cx="2212975" cy="1524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82550" y="4263390"/>
              <a:ext cx="6661150" cy="61595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85408" y="4110990"/>
              <a:ext cx="2524441" cy="1524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82550" y="2294890"/>
              <a:ext cx="6661150" cy="18161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4" name="직사각형 3"/>
          <p:cNvSpPr/>
          <p:nvPr/>
        </p:nvSpPr>
        <p:spPr>
          <a:xfrm>
            <a:off x="0" y="975271"/>
            <a:ext cx="6858000" cy="80945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) BMCTV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3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cgttcaccatcatttcaaattaaagccaaaaatatctttctaacatacccacgatgttcagttataaaagaagatgctctagaaatattgaaaaatattccttgcccatctgataaattatttattagagtatcccaggaaaaacatcaggatg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tctccacgccctcatccaattcaaaggtaaagcacaattcagaaaccctagacacttcgacatcactcatccttcctcaagctccaccttccaccccaacttccaaggagcaaaatctgcatccgatgttaaacaatacatcgagaaggacggtgattacgtcgactggggtacatttcaagtcgacggaagatctgctagaggaggccagcagacggctaatgatgcagcagcagaagcattaaatgcaggtaatgcagctgaagcactgcaaataataagggagaaactcccagaaaaatatatttttcagtatcacaaccttaaacctaacttagaagccatttttcttcctccaccagatatttatcaacctccattcccacaatcttctttcactcaagttccagaaattgttcaagagtgggcagattcttatttcggggtggatgccgctgcgcggccttttagatataatagtataatcatagagggtgattctagaacgggtaagactttgtgggctagatcattaggacctcataattacatttcagggcatttagattttagtttaaaaacatatcacgatgatgttttatataacgtcattgatgacgtagacccagcttacttaaagatgaagcattggaaacacctcataggcgcacaaagagagtggcagacaaacttaaagtatggaaaaccacgtgtcattaaaggtggtattcccagtattatattatgcaacccaggagatggcagctcttaccaggacttcctagataaatcagaaa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aagcccttaagtcctggactatacagaattcaaccttcgttaaactctccggccctctctttgataaagatacagaagcgtcctcgcaaggtcaatctcccctgtaagtgtcacttcacaattcatcatgactgccatcacggattttcgcacggaactacctattaccctggaacaggcgacgaaatcaacaccaacaacatcggttccgaatccactctacttcaaactcctatggttcgagagatacggaacgatttatcaactcaaagtccagatgagattcaaccacaacctccgcaaatcgctcaacctgcacaagtgttggatcgatatgacgataactggatcccacaggacattgactg</a:t>
            </a:r>
            <a:r>
              <a:rPr lang="en-US" altLang="ko-KR" sz="1000" dirty="0" smtClean="0">
                <a:solidFill>
                  <a:srgbClr val="0000FF"/>
                </a:solidFill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GAGTCC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ttttgagagtcttgaagaaccaagtcgacagggaaatcaaaaaacgatcttctctctcaatt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tgtaatagaaatattaaatcatgtattgtattct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TT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ttcgtcaatagtgtaatacaatatactagtattgcaatgaagttgtattaa</a:t>
            </a:r>
            <a:endParaRPr lang="en-US" altLang="ko-KR" sz="1000" kern="0" dirty="0" smtClean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)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MCT</a:t>
            </a:r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12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cgttcaccatcatttcaaattaaagccaaaaatatctttctaacatacccacgatgttcagttataaaagaagatgctctagaaatattgaaaaatattccttgcccatctgataaattatttattagagtatcccaggaaaaacatcaggatg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tctccacgccctcatccaattcaaaggtaaagcacaattcagaaaccctagacacttcgacatcactcatccttcctcaagctccaccttccaccccaacttccaaggagcaaaatctgcatccgatgttaaacaatacatcgagaaggacggtgattacgtcgactggggtacatttcaagtcgacggaagatctgctagaggaggccagcagacggctaatgatgcagcagcagaagcattaaatgcaggtaatgcagctgaagcactgcaaataataagggagaaactcccagaaaaatatatttttcagtatcacaaccttaaacctaacttagaagccatttttcttcctccaccagatatttatcaacctccattcccacaatcttctttcactcaagttccagaaattgttcaagagtgggcagattcttatttcggggtggatgccgctgcgcggccttttagatataatagtataatcatagagggtgattctagaacgggtaagactttgtgggctagatcattaggacctcataattacatttcagggcatttagattttagtttaaaaacatatcacgatgatgttttatataacgtcattgatgacgtagacccagcttacttaaagatgaagcattggaaacacctcataggcgcacaaagagagtggcagacaaacttaaagtatggaaaaccacgtgtcattaaaggtggtattcccagtattatattatgcaacccaggagatggcagctcttaccaggacttcctagataaatcagaaa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aagcccttaagtcctggactatacagaattcaaccttcgttaaactctccggccctctctttgataaagatacagaagcgtcctcgcaaggtcaatctcccctgtaagtgtcacttcacaattcatca</a:t>
            </a:r>
            <a:r>
              <a:rPr lang="en-US" altLang="ko-KR" sz="1000" b="1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ctgccatcacggattttcgcacggaactacctattaccctggaacaggcgacgaaatcaacaccaacaacatcggttccgaatccactctacttcaaactcctatggttcgagagatacggaacgatttatcaactcaaagtccagatgagattcaaccacaacctccgcaaatcgctcaacctgcacaagtgttggatcgatatgacgataactggatcccacaggacattgactg</a:t>
            </a:r>
            <a:r>
              <a:rPr lang="en-US" altLang="ko-KR" sz="1000" dirty="0" smtClean="0">
                <a:solidFill>
                  <a:srgbClr val="0000FF"/>
                </a:solidFill>
                <a:uFill>
                  <a:solidFill>
                    <a:srgbClr val="FF0000"/>
                  </a:solidFill>
                </a:uFill>
                <a:latin typeface="Courier New" panose="02070309020205020404" pitchFamily="49" charset="0"/>
                <a:cs typeface="Courier New" panose="02070309020205020404" pitchFamily="49" charset="0"/>
              </a:rPr>
              <a:t>GAGTCC</a:t>
            </a:r>
            <a:r>
              <a:rPr lang="en-US" altLang="ko-KR" sz="10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ttttgagagtcttgaagaaccaagtcgacagggaaatcaaaaaacgatcttctctctcaattaa</a:t>
            </a:r>
            <a:endParaRPr lang="en-US" altLang="ko-KR" sz="1000" kern="0" dirty="0" smtClean="0">
              <a:solidFill>
                <a:srgbClr val="00B0F0"/>
              </a:solidFill>
              <a:uFill>
                <a:solidFill>
                  <a:srgbClr val="000000"/>
                </a:solidFill>
              </a:u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) </a:t>
            </a:r>
            <a:r>
              <a:rPr lang="en-US" altLang="ko-KR" sz="1000" b="1" kern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MCT</a:t>
            </a:r>
            <a:r>
              <a:rPr lang="en-US" altLang="ko-KR" sz="1000" b="1" kern="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 C1</a:t>
            </a:r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ea typeface="함초롬바탕" panose="02030604000101010101" pitchFamily="18" charset="-127"/>
              <a:cs typeface="Courier New" panose="02070309020205020404" pitchFamily="49" charset="0"/>
            </a:endParaRPr>
          </a:p>
          <a:p>
            <a:pPr algn="just" fontAlgn="base" latinLnBrk="1"/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cgttcaccatcatttcaaattaaagccaaaaatatctttctaacatacccacgatgttcagttataaaagaagatgctctagaaatattgaaaaatattccttgcccatctgataaattatttattagagtatcccaggaaaaacatcaggatg</a:t>
            </a:r>
            <a:r>
              <a:rPr lang="en-US" altLang="ko-KR" sz="10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TCA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tctccacgccctcatccaattcaaaggtaaagcacaattcagaaaccctagacacttcgacatcactcatccttcctcaagctccaccttccaccccaacttccaaggagcaaaatctgcatccgatgttaaacaatacatcgagaaggacggtgattacgtcgactggggtacatttcaagtcgacggaagatctgctagaggaggccagcagacggctaatgatgcagcagcagaagcattaaatgcaggtaatgcagctgaagcactgcaaataataagggagaaactcccagaaaaatatatttttcagtatcacaaccttaaacctaacttagaagccatttttcttcctccaccagatatttatcaacctccattcccacaatcttctttcactcaagttccagaaattgttcaagagtgggcagattcttatttcggggtggatgccgctgcgcggccttttagatataatagtataatcatagagggtgattctagaacgggtaagactttgtgggctagatcattaggacctcataattacatttcagggcatttagattttagtttaaaaacatatcacgatgatgttttatataacgtcattgatgacgtagacccagcttacttaaagatgaagcattggaaacacctcataggcgcacaaagagagtggcagacaaacttaaagtatggaaaaccacgtgtcattaaaggtggtattcccagtattatattatgcaacccaggagatggcagctcttaccaggacttcctagataaatcagaaaa</a:t>
            </a:r>
            <a:r>
              <a:rPr lang="en-US" altLang="ko-KR" sz="1000" b="1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gcccttaagtcctggactatacagaattcaaccttcgttaaactctccggccctctctttgataaagatacagaagcgtcctcgcaaggtcaatctcccctgtaa</a:t>
            </a:r>
            <a:endParaRPr lang="en-US" altLang="ko-KR" sz="1000" kern="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 fontAlgn="base" latinLnBrk="1"/>
            <a:endParaRPr lang="en-US" altLang="ko-KR" sz="1000" kern="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0" y="0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lappe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F sequences of genes associated with the viral DNA replication (C1, C2, C3 and C4) 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CTV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in this study. a) BMC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, C2 and C3 ORFs. b) BMC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and C2 ORFs. c) BMC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ORF. C1 (pale orange background), C2 (sky blue characters), C3 (gray background) and C4 (underlined characters in pale orange background) ORFs from BMC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d and blue uppercase letters represent the modified sequences from the recognition sites of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i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sa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out alteration of amino acid, respectively. Purple bold uppercase letter indicates a modified start codon without alteration of amino acid.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433970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425450"/>
            <a:ext cx="6858000" cy="24006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 latinLnBrk="1"/>
            <a:r>
              <a:rPr lang="en-US" altLang="ko-KR" sz="1000" b="1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&gt;TYLCV IR 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(306 </a:t>
            </a:r>
            <a:r>
              <a:rPr lang="en-US" altLang="ko-KR" sz="1000" kern="0" dirty="0" err="1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bp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)</a:t>
            </a:r>
          </a:p>
          <a:p>
            <a:pPr algn="just" fontAlgn="base" latinLnBrk="1"/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gttgaaatgaatcggtgtccctcaaagctctatggcaatcggtgtatcggtgtcttacttatacctggacacctaatggctatttggtaatttcatgaatgttcattgtaattcaaaattcaaaaatcaaatcattaaagcggccatccgta</a:t>
            </a:r>
            <a:r>
              <a:rPr lang="en-US" altLang="ko-KR" sz="1000" b="1" kern="0" dirty="0" smtClean="0">
                <a:solidFill>
                  <a:srgbClr val="C00000"/>
                </a:solidFill>
                <a:uFill>
                  <a:solidFill>
                    <a:srgbClr val="000000"/>
                  </a:solidFill>
                </a:u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atatta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ggatggccgcgccttttccttttatgtggtccccacgagggttacacagacgtcactgtcaaccaatcaaattgcatcctcaaacgttagataagtgttcatttgtctttatatacttggtccccaagttttttgtcttgcaat</a:t>
            </a:r>
          </a:p>
          <a:p>
            <a:pPr algn="just" fontAlgn="base" latinLnBrk="1"/>
            <a:r>
              <a:rPr lang="en-US" altLang="ko-KR" sz="1000" b="1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&gt;HYVV IR 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(299 </a:t>
            </a:r>
            <a:r>
              <a:rPr lang="en-US" altLang="ko-KR" sz="1000" kern="0" dirty="0" err="1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bp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)</a:t>
            </a:r>
          </a:p>
          <a:p>
            <a:pPr algn="just" fontAlgn="base" latinLnBrk="1"/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ttgacttggtcaattggggggcacttcaaactcctgctgaatgggggggcattggggggcaatttatattctggggggcatggcattattgtaattactttaattttaaattcaagattcaaattggtaaagcggccatccgta</a:t>
            </a:r>
            <a:r>
              <a:rPr lang="en-US" altLang="ko-KR" sz="1000" b="1" kern="0" dirty="0" smtClean="0">
                <a:solidFill>
                  <a:srgbClr val="C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atatta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ggatggccgcccgaaatttcgtggtggtcccccccttgtcggccaatgaataacgtgccttgaatgttagataagtggaaagtgacgtttgcttttgtctttatatacgtcagccctaattttaacggtgtaag</a:t>
            </a:r>
          </a:p>
          <a:p>
            <a:pPr algn="just" fontAlgn="base" latinLnBrk="1"/>
            <a:r>
              <a:rPr lang="en-US" altLang="ko-KR" sz="1000" b="1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&gt;BMCTV IR 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(345 </a:t>
            </a:r>
            <a:r>
              <a:rPr lang="en-US" altLang="ko-KR" sz="1000" kern="0" dirty="0" err="1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bp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)</a:t>
            </a:r>
          </a:p>
          <a:p>
            <a:pPr algn="just" fontAlgn="base" latinLnBrk="1"/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gttactattcctattgggggctctcgtaaacttgtatgaatggggtgctatgggagcccttatatacctccaggggccatccgcaa</a:t>
            </a:r>
            <a:r>
              <a:rPr lang="en-US" altLang="ko-KR" sz="1000" b="1" kern="0" dirty="0" smtClean="0">
                <a:solidFill>
                  <a:srgbClr val="C00000"/>
                </a:solidFill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taatattac</a:t>
            </a:r>
            <a:r>
              <a:rPr lang="en-US" altLang="ko-KR" sz="1000" kern="0" dirty="0" smtClean="0">
                <a:latin typeface="Courier New" panose="02070309020205020404" pitchFamily="49" charset="0"/>
                <a:ea typeface="함초롬바탕" panose="02030604000101010101" pitchFamily="18" charset="-127"/>
                <a:cs typeface="Courier New" panose="02070309020205020404" pitchFamily="49" charset="0"/>
              </a:rPr>
              <a:t>cggatggccccgaaaattttgcccccccaattgtaacgtgacacgtgttatcgcattatacgttgtcggtgcttggaaacttcctatgtaagtttccttctctaacaagttttgactagtcaaaagttgcggccgacaactacctttacttttttaaagtaaagtaagtttattattcaaaacttgctgtgtaagtttggaatatttttctatttaaatagctatacgaatacgtataggtatttataa</a:t>
            </a:r>
            <a:endParaRPr lang="en-US" altLang="ko-KR" sz="1000" kern="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sequences of intergenic region (IR) from TYLCV, HYVV and BMCTV used in this study. Brown bold character indicates the universal motif for viral DNA replication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34649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</TotalTime>
  <Words>789</Words>
  <Application>Microsoft Office PowerPoint</Application>
  <PresentationFormat>A4 용지(210x297mm)</PresentationFormat>
  <Paragraphs>107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3" baseType="lpstr">
      <vt:lpstr>맑은 고딕</vt:lpstr>
      <vt:lpstr>함초롬바탕</vt:lpstr>
      <vt:lpstr>Arial</vt:lpstr>
      <vt:lpstr>Calibri</vt:lpstr>
      <vt:lpstr>Calibri Light</vt:lpstr>
      <vt:lpstr>Courier New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</dc:creator>
  <cp:lastModifiedBy>user</cp:lastModifiedBy>
  <cp:revision>41</cp:revision>
  <dcterms:created xsi:type="dcterms:W3CDTF">2023-11-06T06:24:23Z</dcterms:created>
  <dcterms:modified xsi:type="dcterms:W3CDTF">2024-06-28T07:20:04Z</dcterms:modified>
</cp:coreProperties>
</file>